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10854-78D2-422F-8600-62A4D09D46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D60C2-2A3E-46B3-B3F6-2509682708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F83A4-96AA-4A13-A4AF-3EC8B79064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8088C-D81E-4265-93B2-C13582F2BC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D175A-83D1-4AE4-9677-66B37326F6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F39F5-1FAA-45E7-AD2E-CBD3A7A26F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7BBD0-DF17-4310-8A5C-5AB26ECF29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83E33-494B-4E28-8D83-1349DBEB8E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3A6F3-F70F-4382-9F6D-FBCFD366DA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97123-8C18-4A19-BF52-1090774199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E00AB-9B66-431D-876B-ACC3739FA8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90CE1-A72E-4E08-B0F2-FF5F379CC1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602AF1-B8BF-442F-99AB-C6AD40C01ADC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package" Target="../embeddings/oleObject2.xlsx"/><Relationship Id="rId9" Type="http://schemas.openxmlformats.org/officeDocument/2006/relationships/image" Target="../media/image3.png"/><Relationship Id="rId10" Type="http://schemas.openxmlformats.org/officeDocument/2006/relationships/image" Target="../media/image2.png"/><Relationship Id="rId11" Type="http://schemas.openxmlformats.org/officeDocument/2006/relationships/image" Target="../media/image2.png"/><Relationship Id="rId12" Type="http://schemas.openxmlformats.org/officeDocument/2006/relationships/image" Target="../media/image2.png"/><Relationship Id="rId13" Type="http://schemas.openxmlformats.org/officeDocument/2006/relationships/image" Target="../media/image2.png"/><Relationship Id="rId14" Type="http://schemas.openxmlformats.org/officeDocument/2006/relationships/image" Target="../media/image2.png"/><Relationship Id="rId15" Type="http://schemas.openxmlformats.org/officeDocument/2006/relationships/package" Target="../embeddings/oleObject3.xlsx"/><Relationship Id="rId16" Type="http://schemas.openxmlformats.org/officeDocument/2006/relationships/image" Target="../media/image4.png"/><Relationship Id="rId17" Type="http://schemas.openxmlformats.org/officeDocument/2006/relationships/image" Target="../media/image2.png"/><Relationship Id="rId18" Type="http://schemas.openxmlformats.org/officeDocument/2006/relationships/image" Target="../media/image2.png"/><Relationship Id="rId19" Type="http://schemas.openxmlformats.org/officeDocument/2006/relationships/image" Target="../media/image2.png"/><Relationship Id="rId20" Type="http://schemas.openxmlformats.org/officeDocument/2006/relationships/image" Target="../media/image2.png"/><Relationship Id="rId21" Type="http://schemas.openxmlformats.org/officeDocument/2006/relationships/image" Target="../media/image2.png"/><Relationship Id="rId22" Type="http://schemas.openxmlformats.org/officeDocument/2006/relationships/image" Target="../media/image2.png"/><Relationship Id="rId23" Type="http://schemas.openxmlformats.org/officeDocument/2006/relationships/image" Target="../media/image2.png"/><Relationship Id="rId24" Type="http://schemas.openxmlformats.org/officeDocument/2006/relationships/image" Target="../media/image2.png"/><Relationship Id="rId2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66920" y="828720"/>
            <a:ext cx="5937120" cy="2189160"/>
            <a:chOff x="466920" y="828720"/>
            <a:chExt cx="5937120" cy="2189160"/>
          </a:xfrm>
        </p:grpSpPr>
        <p:graphicFrame>
          <p:nvGraphicFramePr>
            <p:cNvPr id="42" name=""/>
            <p:cNvGraphicFramePr/>
            <p:nvPr/>
          </p:nvGraphicFramePr>
          <p:xfrm>
            <a:off x="746280" y="1133640"/>
            <a:ext cx="5657760" cy="12585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746280" y="1133640"/>
                      <a:ext cx="5657760" cy="1258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505080" y="855720"/>
              <a:ext cx="5889600" cy="21463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1082880" y="2043000"/>
              <a:ext cx="141120" cy="142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4"/>
            <a:stretch/>
          </p:blipFill>
          <p:spPr>
            <a:xfrm>
              <a:off x="1381320" y="1959120"/>
              <a:ext cx="14112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5"/>
            <a:stretch/>
          </p:blipFill>
          <p:spPr>
            <a:xfrm>
              <a:off x="1679760" y="2016000"/>
              <a:ext cx="141120" cy="1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6"/>
            <a:stretch/>
          </p:blipFill>
          <p:spPr>
            <a:xfrm>
              <a:off x="3446640" y="2043000"/>
              <a:ext cx="141120" cy="142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7"/>
            <a:stretch/>
          </p:blipFill>
          <p:spPr>
            <a:xfrm>
              <a:off x="5515200" y="1986120"/>
              <a:ext cx="141120" cy="14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"/>
            <p:cNvSpPr/>
            <p:nvPr/>
          </p:nvSpPr>
          <p:spPr>
            <a:xfrm rot="18829800">
              <a:off x="4005000" y="2487240"/>
              <a:ext cx="55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8829800">
              <a:off x="4300920" y="2496960"/>
              <a:ext cx="56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8829800">
              <a:off x="4880880" y="2481840"/>
              <a:ext cx="56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8829800">
              <a:off x="4587840" y="2487960"/>
              <a:ext cx="55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to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8829800">
              <a:off x="3731760" y="2481120"/>
              <a:ext cx="54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rax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8829800">
              <a:off x="3273120" y="2420640"/>
              <a:ext cx="35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i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8829800">
              <a:off x="2989080" y="2428920"/>
              <a:ext cx="36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8829800">
              <a:off x="2669400" y="243072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3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8829800">
              <a:off x="2380320" y="243180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8829800">
              <a:off x="1987200" y="247608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32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8829800">
              <a:off x="1788120" y="243036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1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8829800">
              <a:off x="1399320" y="247392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31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8829800">
              <a:off x="1210320" y="243684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18829800">
              <a:off x="913680" y="243540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9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8829800">
              <a:off x="5049000" y="2548800"/>
              <a:ext cx="724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ultifloren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8829800">
              <a:off x="5306760" y="2557800"/>
              <a:ext cx="768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Ψ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tarax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8829800">
              <a:off x="5697000" y="2521800"/>
              <a:ext cx="66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rax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8829800">
              <a:off x="3307680" y="2534400"/>
              <a:ext cx="68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igm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272200" y="936720"/>
              <a:ext cx="104760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9" name=""/>
            <p:cNvGrpSpPr/>
            <p:nvPr/>
          </p:nvGrpSpPr>
          <p:grpSpPr>
            <a:xfrm>
              <a:off x="5729400" y="1012680"/>
              <a:ext cx="469800" cy="448920"/>
              <a:chOff x="5729400" y="1012680"/>
              <a:chExt cx="469800" cy="448920"/>
            </a:xfrm>
          </p:grpSpPr>
          <p:sp>
            <p:nvSpPr>
              <p:cNvPr id="70" name=""/>
              <p:cNvSpPr/>
              <p:nvPr/>
            </p:nvSpPr>
            <p:spPr>
              <a:xfrm>
                <a:off x="5729400" y="1012680"/>
                <a:ext cx="469800" cy="44892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5775480" y="1082520"/>
                <a:ext cx="84240" cy="9180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5918760" y="105552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5775480" y="1293840"/>
                <a:ext cx="84240" cy="9000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961240" y="1265040"/>
                <a:ext cx="67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" name=""/>
            <p:cNvSpPr/>
            <p:nvPr/>
          </p:nvSpPr>
          <p:spPr>
            <a:xfrm>
              <a:off x="3222000" y="933480"/>
              <a:ext cx="906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eak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rot="16200000">
              <a:off x="-55440" y="1688760"/>
              <a:ext cx="1372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%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f total wax loa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66920" y="8287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466920" y="3103560"/>
            <a:ext cx="5951520" cy="2198160"/>
            <a:chOff x="466920" y="3103560"/>
            <a:chExt cx="5951520" cy="2198160"/>
          </a:xfrm>
        </p:grpSpPr>
        <p:graphicFrame>
          <p:nvGraphicFramePr>
            <p:cNvPr id="79" name=""/>
            <p:cNvGraphicFramePr/>
            <p:nvPr/>
          </p:nvGraphicFramePr>
          <p:xfrm>
            <a:off x="741600" y="3417480"/>
            <a:ext cx="5676840" cy="1298520"/>
          </p:xfrm>
          <a:graphic>
            <a:graphicData uri="http://schemas.openxmlformats.org/presentationml/2006/ole">
              <p:oleObj progId="Excel.Sheet.12" r:id="rId8" spid="">
                <p:embed/>
                <p:pic>
                  <p:nvPicPr>
                    <p:cNvPr id="80" name="" descr=""/>
                    <p:cNvPicPr/>
                    <p:nvPr/>
                  </p:nvPicPr>
                  <p:blipFill>
                    <a:blip r:embed="rId9"/>
                    <a:stretch/>
                  </p:blipFill>
                  <p:spPr>
                    <a:xfrm>
                      <a:off x="741600" y="3417480"/>
                      <a:ext cx="5676840" cy="1298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1" name=""/>
            <p:cNvSpPr/>
            <p:nvPr/>
          </p:nvSpPr>
          <p:spPr>
            <a:xfrm>
              <a:off x="505080" y="3125520"/>
              <a:ext cx="5886360" cy="21474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2" name="" descr=""/>
            <p:cNvPicPr/>
            <p:nvPr/>
          </p:nvPicPr>
          <p:blipFill>
            <a:blip r:embed="rId10"/>
            <a:stretch/>
          </p:blipFill>
          <p:spPr>
            <a:xfrm>
              <a:off x="2884680" y="4393800"/>
              <a:ext cx="14112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" descr=""/>
            <p:cNvPicPr/>
            <p:nvPr/>
          </p:nvPicPr>
          <p:blipFill>
            <a:blip r:embed="rId11"/>
            <a:stretch/>
          </p:blipFill>
          <p:spPr>
            <a:xfrm>
              <a:off x="3468600" y="4384440"/>
              <a:ext cx="141480" cy="14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" descr=""/>
            <p:cNvPicPr/>
            <p:nvPr/>
          </p:nvPicPr>
          <p:blipFill>
            <a:blip r:embed="rId12"/>
            <a:stretch/>
          </p:blipFill>
          <p:spPr>
            <a:xfrm>
              <a:off x="4630680" y="3749400"/>
              <a:ext cx="14148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" descr=""/>
            <p:cNvPicPr/>
            <p:nvPr/>
          </p:nvPicPr>
          <p:blipFill>
            <a:blip r:embed="rId13"/>
            <a:stretch/>
          </p:blipFill>
          <p:spPr>
            <a:xfrm>
              <a:off x="4945320" y="4362120"/>
              <a:ext cx="14112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" descr=""/>
            <p:cNvPicPr/>
            <p:nvPr/>
          </p:nvPicPr>
          <p:blipFill>
            <a:blip r:embed="rId14"/>
            <a:stretch/>
          </p:blipFill>
          <p:spPr>
            <a:xfrm>
              <a:off x="5227560" y="3854160"/>
              <a:ext cx="141480" cy="14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"/>
            <p:cNvSpPr/>
            <p:nvPr/>
          </p:nvSpPr>
          <p:spPr>
            <a:xfrm rot="16200000">
              <a:off x="-55440" y="3982320"/>
              <a:ext cx="1372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%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f total wax loa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66920" y="310356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286600" y="3192120"/>
              <a:ext cx="1047600" cy="456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" name=""/>
            <p:cNvGrpSpPr/>
            <p:nvPr/>
          </p:nvGrpSpPr>
          <p:grpSpPr>
            <a:xfrm>
              <a:off x="5729400" y="3287160"/>
              <a:ext cx="469800" cy="448560"/>
              <a:chOff x="5729400" y="3287160"/>
              <a:chExt cx="469800" cy="448560"/>
            </a:xfrm>
          </p:grpSpPr>
          <p:sp>
            <p:nvSpPr>
              <p:cNvPr id="91" name=""/>
              <p:cNvSpPr/>
              <p:nvPr/>
            </p:nvSpPr>
            <p:spPr>
              <a:xfrm>
                <a:off x="5729400" y="3287160"/>
                <a:ext cx="469800" cy="44856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5775480" y="3357000"/>
                <a:ext cx="84240" cy="9180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5918760" y="333000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5775480" y="3567960"/>
                <a:ext cx="84240" cy="9000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961240" y="3539160"/>
                <a:ext cx="67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" name=""/>
            <p:cNvSpPr/>
            <p:nvPr/>
          </p:nvSpPr>
          <p:spPr>
            <a:xfrm>
              <a:off x="3227400" y="3246120"/>
              <a:ext cx="854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rang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8829800">
              <a:off x="4015800" y="4771440"/>
              <a:ext cx="55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8829800">
              <a:off x="4312080" y="4781520"/>
              <a:ext cx="56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18829800">
              <a:off x="4891680" y="4765320"/>
              <a:ext cx="56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rot="18829800">
              <a:off x="4599000" y="4771440"/>
              <a:ext cx="55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to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18829800">
              <a:off x="3743280" y="4764600"/>
              <a:ext cx="54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rax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8829800">
              <a:off x="3284280" y="4704480"/>
              <a:ext cx="35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i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18829800">
              <a:off x="3000240" y="4712760"/>
              <a:ext cx="36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18829800">
              <a:off x="2680920" y="471420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3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18829800">
              <a:off x="2391480" y="471600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8829800">
              <a:off x="1998360" y="475992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32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18829800">
              <a:off x="1799640" y="471384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1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18829800">
              <a:off x="1410480" y="475812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31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18829800">
              <a:off x="1221480" y="472068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rot="18829800">
              <a:off x="924840" y="471852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9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rot="18829800">
              <a:off x="5060160" y="4833000"/>
              <a:ext cx="724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ultifloren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rot="18829800">
              <a:off x="5317920" y="4841640"/>
              <a:ext cx="768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Ψ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tarax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rot="18829800">
              <a:off x="5707800" y="4806360"/>
              <a:ext cx="66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rax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rot="18829800">
              <a:off x="3318840" y="4818240"/>
              <a:ext cx="68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igm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5" name=""/>
          <p:cNvSpPr/>
          <p:nvPr/>
        </p:nvSpPr>
        <p:spPr>
          <a:xfrm>
            <a:off x="38160" y="44280"/>
            <a:ext cx="2209680" cy="47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Figure S7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6" name=""/>
          <p:cNvGrpSpPr/>
          <p:nvPr/>
        </p:nvGrpSpPr>
        <p:grpSpPr>
          <a:xfrm>
            <a:off x="466920" y="5394240"/>
            <a:ext cx="5930640" cy="2246760"/>
            <a:chOff x="466920" y="5394240"/>
            <a:chExt cx="5930640" cy="2246760"/>
          </a:xfrm>
        </p:grpSpPr>
        <p:graphicFrame>
          <p:nvGraphicFramePr>
            <p:cNvPr id="117" name=""/>
            <p:cNvGraphicFramePr/>
            <p:nvPr/>
          </p:nvGraphicFramePr>
          <p:xfrm>
            <a:off x="709560" y="5705640"/>
            <a:ext cx="5676840" cy="1433520"/>
          </p:xfrm>
          <a:graphic>
            <a:graphicData uri="http://schemas.openxmlformats.org/presentationml/2006/ole">
              <p:oleObj progId="Excel.Sheet.12" r:id="rId15" spid="">
                <p:embed/>
                <p:pic>
                  <p:nvPicPr>
                    <p:cNvPr id="118" name="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709560" y="5705640"/>
                      <a:ext cx="5676840" cy="1433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pic>
          <p:nvPicPr>
            <p:cNvPr id="119" name="" descr=""/>
            <p:cNvPicPr/>
            <p:nvPr/>
          </p:nvPicPr>
          <p:blipFill>
            <a:blip r:embed="rId17"/>
            <a:stretch/>
          </p:blipFill>
          <p:spPr>
            <a:xfrm>
              <a:off x="1670040" y="6740640"/>
              <a:ext cx="14112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" descr=""/>
            <p:cNvPicPr/>
            <p:nvPr/>
          </p:nvPicPr>
          <p:blipFill>
            <a:blip r:embed="rId18"/>
            <a:stretch/>
          </p:blipFill>
          <p:spPr>
            <a:xfrm>
              <a:off x="3460680" y="6743880"/>
              <a:ext cx="14148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1" name="" descr=""/>
            <p:cNvPicPr/>
            <p:nvPr/>
          </p:nvPicPr>
          <p:blipFill>
            <a:blip r:embed="rId19"/>
            <a:stretch/>
          </p:blipFill>
          <p:spPr>
            <a:xfrm>
              <a:off x="3759120" y="6708600"/>
              <a:ext cx="141480" cy="1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2" name="" descr=""/>
            <p:cNvPicPr/>
            <p:nvPr/>
          </p:nvPicPr>
          <p:blipFill>
            <a:blip r:embed="rId20"/>
            <a:stretch/>
          </p:blipFill>
          <p:spPr>
            <a:xfrm>
              <a:off x="4359240" y="6137280"/>
              <a:ext cx="14148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" descr=""/>
            <p:cNvPicPr/>
            <p:nvPr/>
          </p:nvPicPr>
          <p:blipFill>
            <a:blip r:embed="rId21"/>
            <a:stretch/>
          </p:blipFill>
          <p:spPr>
            <a:xfrm>
              <a:off x="4638600" y="6048360"/>
              <a:ext cx="141480" cy="1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" descr=""/>
            <p:cNvPicPr/>
            <p:nvPr/>
          </p:nvPicPr>
          <p:blipFill>
            <a:blip r:embed="rId22"/>
            <a:stretch/>
          </p:blipFill>
          <p:spPr>
            <a:xfrm>
              <a:off x="5549760" y="6711840"/>
              <a:ext cx="141480" cy="141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5" name="" descr=""/>
            <p:cNvPicPr/>
            <p:nvPr/>
          </p:nvPicPr>
          <p:blipFill>
            <a:blip r:embed="rId23"/>
            <a:stretch/>
          </p:blipFill>
          <p:spPr>
            <a:xfrm>
              <a:off x="5838840" y="6718320"/>
              <a:ext cx="141120" cy="1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6" name="" descr=""/>
            <p:cNvPicPr/>
            <p:nvPr/>
          </p:nvPicPr>
          <p:blipFill>
            <a:blip r:embed="rId24"/>
            <a:stretch/>
          </p:blipFill>
          <p:spPr>
            <a:xfrm>
              <a:off x="6140520" y="6743880"/>
              <a:ext cx="141120" cy="14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7" name=""/>
            <p:cNvSpPr/>
            <p:nvPr/>
          </p:nvSpPr>
          <p:spPr>
            <a:xfrm rot="18829800">
              <a:off x="4038120" y="7110000"/>
              <a:ext cx="55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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rot="18829800">
              <a:off x="4334040" y="7119720"/>
              <a:ext cx="56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rot="18829800">
              <a:off x="4914360" y="7104240"/>
              <a:ext cx="56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myr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rot="18829800">
              <a:off x="4620960" y="7110360"/>
              <a:ext cx="55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to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rot="18829800">
              <a:off x="3764880" y="7103880"/>
              <a:ext cx="54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rax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8829800">
              <a:off x="3306600" y="7043400"/>
              <a:ext cx="35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i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8829800">
              <a:off x="2993760" y="7051680"/>
              <a:ext cx="36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18829800">
              <a:off x="2693160" y="705348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3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rot="18829800">
              <a:off x="2385000" y="705492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rot="18829800">
              <a:off x="1991880" y="709884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32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8829800">
              <a:off x="1792800" y="705312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1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8829800">
              <a:off x="1394640" y="709704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so31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8829800">
              <a:off x="1205640" y="705996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rot="18829800">
              <a:off x="899280" y="705816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9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8829800">
              <a:off x="5082120" y="7171560"/>
              <a:ext cx="724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ultifloren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rot="18829800">
              <a:off x="5339880" y="7180920"/>
              <a:ext cx="768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Ψ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tarax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rot="18829800">
              <a:off x="5730120" y="7144200"/>
              <a:ext cx="66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arax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rot="18829800">
              <a:off x="3341160" y="7157520"/>
              <a:ext cx="68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igmaste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349960" y="5530680"/>
              <a:ext cx="1047600" cy="457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6" name=""/>
            <p:cNvGrpSpPr/>
            <p:nvPr/>
          </p:nvGrpSpPr>
          <p:grpSpPr>
            <a:xfrm>
              <a:off x="5770440" y="5597280"/>
              <a:ext cx="469800" cy="448920"/>
              <a:chOff x="5770440" y="5597280"/>
              <a:chExt cx="469800" cy="448920"/>
            </a:xfrm>
          </p:grpSpPr>
          <p:sp>
            <p:nvSpPr>
              <p:cNvPr id="147" name=""/>
              <p:cNvSpPr/>
              <p:nvPr/>
            </p:nvSpPr>
            <p:spPr>
              <a:xfrm>
                <a:off x="5770440" y="5597280"/>
                <a:ext cx="469800" cy="44892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5816520" y="5667120"/>
                <a:ext cx="84240" cy="9180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5959800" y="5640120"/>
                <a:ext cx="236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5816520" y="5878440"/>
                <a:ext cx="84240" cy="9000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6002280" y="5849640"/>
                <a:ext cx="67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2" name=""/>
            <p:cNvSpPr/>
            <p:nvPr/>
          </p:nvSpPr>
          <p:spPr>
            <a:xfrm rot="16200000">
              <a:off x="-42840" y="6244920"/>
              <a:ext cx="1372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%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f total wax loa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66920" y="53942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3402000" y="5518080"/>
              <a:ext cx="549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06520" y="5403960"/>
              <a:ext cx="5886360" cy="214776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3:48:09Z</dcterms:modified>
  <cp:revision>9</cp:revision>
  <dc:subject/>
  <dc:title>Slide 1</dc:title>
</cp:coreProperties>
</file>